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4" d="100"/>
          <a:sy n="114" d="100"/>
        </p:scale>
        <p:origin x="-1518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1101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373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1565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6195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3305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5976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6544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897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5158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2080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4849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25F3A-A133-4310-9507-6AB85F55D1FE}" type="datetimeFigureOut">
              <a:rPr lang="es-ES" smtClean="0"/>
              <a:t>16/06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483FF-D228-4E74-958C-1B0260A1E1C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6223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3 Grupo"/>
          <p:cNvGrpSpPr/>
          <p:nvPr/>
        </p:nvGrpSpPr>
        <p:grpSpPr>
          <a:xfrm>
            <a:off x="2387060" y="2027268"/>
            <a:ext cx="4653887" cy="4714100"/>
            <a:chOff x="1531918" y="3784672"/>
            <a:chExt cx="3978232" cy="4211298"/>
          </a:xfrm>
        </p:grpSpPr>
        <p:sp>
          <p:nvSpPr>
            <p:cNvPr id="5" name="4 Elipse"/>
            <p:cNvSpPr/>
            <p:nvPr/>
          </p:nvSpPr>
          <p:spPr>
            <a:xfrm>
              <a:off x="3211506" y="5355771"/>
              <a:ext cx="1930510" cy="1900052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" name="5 Elipse"/>
            <p:cNvSpPr/>
            <p:nvPr/>
          </p:nvSpPr>
          <p:spPr>
            <a:xfrm>
              <a:off x="2576945" y="3784672"/>
              <a:ext cx="2933205" cy="2865509"/>
            </a:xfrm>
            <a:prstGeom prst="ellipse">
              <a:avLst/>
            </a:prstGeom>
            <a:solidFill>
              <a:schemeClr val="accent6">
                <a:lumMod val="60000"/>
                <a:lumOff val="40000"/>
                <a:alpha val="50000"/>
              </a:schemeClr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" name="6 Elipse"/>
            <p:cNvSpPr/>
            <p:nvPr/>
          </p:nvSpPr>
          <p:spPr>
            <a:xfrm>
              <a:off x="1531918" y="4635961"/>
              <a:ext cx="3288694" cy="3360009"/>
            </a:xfrm>
            <a:prstGeom prst="ellipse">
              <a:avLst/>
            </a:prstGeom>
            <a:solidFill>
              <a:schemeClr val="accent3">
                <a:lumMod val="60000"/>
                <a:lumOff val="40000"/>
                <a:alpha val="60000"/>
              </a:schemeClr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8" name="7 CuadroTexto"/>
            <p:cNvSpPr txBox="1"/>
            <p:nvPr/>
          </p:nvSpPr>
          <p:spPr>
            <a:xfrm>
              <a:off x="1936209" y="6350420"/>
              <a:ext cx="858541" cy="4878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ptide Library</a:t>
              </a:r>
              <a:endPara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3640776" y="4056925"/>
              <a:ext cx="1021507" cy="2927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tabases</a:t>
              </a:r>
              <a:endPara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9 CuadroTexto"/>
            <p:cNvSpPr txBox="1"/>
            <p:nvPr/>
          </p:nvSpPr>
          <p:spPr>
            <a:xfrm>
              <a:off x="3640776" y="5573416"/>
              <a:ext cx="858541" cy="4878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M method</a:t>
              </a:r>
              <a:endPara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10 CuadroTexto"/>
            <p:cNvSpPr txBox="1"/>
            <p:nvPr/>
          </p:nvSpPr>
          <p:spPr>
            <a:xfrm>
              <a:off x="1936209" y="6838271"/>
              <a:ext cx="858541" cy="2927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11 CuadroTexto"/>
            <p:cNvSpPr txBox="1"/>
            <p:nvPr/>
          </p:nvSpPr>
          <p:spPr>
            <a:xfrm>
              <a:off x="3722259" y="4343250"/>
              <a:ext cx="858541" cy="2927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12 CuadroTexto"/>
            <p:cNvSpPr txBox="1"/>
            <p:nvPr/>
          </p:nvSpPr>
          <p:spPr>
            <a:xfrm>
              <a:off x="3640776" y="6054881"/>
              <a:ext cx="858541" cy="2927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13 CuadroTexto"/>
            <p:cNvSpPr txBox="1"/>
            <p:nvPr/>
          </p:nvSpPr>
          <p:spPr>
            <a:xfrm>
              <a:off x="2782235" y="5116382"/>
              <a:ext cx="858541" cy="2927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</a:t>
              </a:r>
              <a:endPara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3640776" y="6709332"/>
              <a:ext cx="858541" cy="2927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4499317" y="5907312"/>
              <a:ext cx="858541" cy="2927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1 CuadroTexto"/>
          <p:cNvSpPr txBox="1"/>
          <p:nvPr/>
        </p:nvSpPr>
        <p:spPr>
          <a:xfrm>
            <a:off x="107504" y="44624"/>
            <a:ext cx="8928992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nn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gram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bases and peptide libr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. </a:t>
            </a: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from open access data bases Peptide Atlas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MAtla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s combined with information from in-house experimental data bases for MRM method development. Preliminary MRM method included 3 or 4 peptides per protein from common peptides between both sources of data and peptides unique from one source of data when more information was required. A second version of the MRM method was built with those peptides from preliminary version that were well detected by MRM.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61716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02</Words>
  <Application>Microsoft Office PowerPoint</Application>
  <PresentationFormat>Presentación en pantalla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ura</dc:creator>
  <cp:lastModifiedBy>Laura </cp:lastModifiedBy>
  <cp:revision>3</cp:revision>
  <dcterms:created xsi:type="dcterms:W3CDTF">2021-06-09T15:10:08Z</dcterms:created>
  <dcterms:modified xsi:type="dcterms:W3CDTF">2021-06-16T07:31:00Z</dcterms:modified>
</cp:coreProperties>
</file>